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revisionInfo.xml" ContentType="application/vnd.ms-powerpoint.revisioninfo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:p15="http://schemas.microsoft.com/office/powerpoint/2012/main" xmlns="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75699" autoAdjust="0"/>
  </p:normalViewPr>
  <p:slideViewPr>
    <p:cSldViewPr snapToGrid="0">
      <p:cViewPr varScale="1">
        <p:scale>
          <a:sx n="58" d="100"/>
          <a:sy n="58" d="100"/>
        </p:scale>
        <p:origin x="-1206" y="-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CA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94A76F5-9347-4581-9EED-32CB555EE33B}" type="datetimeFigureOut">
              <a:rPr lang="fr-CA" smtClean="0"/>
              <a:pPr/>
              <a:t>2018-01-12</a:t>
            </a:fld>
            <a:endParaRPr lang="fr-CA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CA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0539078-B2D5-4A60-A62A-B444EC0E9DA0}" type="slidenum">
              <a:rPr lang="fr-CA" smtClean="0"/>
              <a:pPr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xmlns="" val="11990813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fr-CA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fr-CA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</a:t>
            </a:r>
            <a:r>
              <a:rPr lang="fr-CA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 62-year-old man presenting with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ipomatous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metaplasia in the lateral wall of the left ventricle, suggestive of myocardial infarction (arrows).</a:t>
            </a:r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0539078-B2D5-4A60-A62A-B444EC0E9DA0}" type="slidenum">
              <a:rPr lang="fr-CA" smtClean="0"/>
              <a:pPr/>
              <a:t>1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xmlns="" val="234685056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r le style des sous-titres du masque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E00C1F-946C-4921-AD88-2564A8031D60}" type="datetimeFigureOut">
              <a:rPr lang="fr-CA" smtClean="0"/>
              <a:pPr/>
              <a:t>2018-01-12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B13B8-C351-4884-A369-C3BB98026AA4}" type="slidenum">
              <a:rPr lang="fr-CA" smtClean="0"/>
              <a:pPr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xmlns="" val="35847938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E00C1F-946C-4921-AD88-2564A8031D60}" type="datetimeFigureOut">
              <a:rPr lang="fr-CA" smtClean="0"/>
              <a:pPr/>
              <a:t>2018-01-12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B13B8-C351-4884-A369-C3BB98026AA4}" type="slidenum">
              <a:rPr lang="fr-CA" smtClean="0"/>
              <a:pPr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xmlns="" val="37616448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E00C1F-946C-4921-AD88-2564A8031D60}" type="datetimeFigureOut">
              <a:rPr lang="fr-CA" smtClean="0"/>
              <a:pPr/>
              <a:t>2018-01-12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B13B8-C351-4884-A369-C3BB98026AA4}" type="slidenum">
              <a:rPr lang="fr-CA" smtClean="0"/>
              <a:pPr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xmlns="" val="32914919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E00C1F-946C-4921-AD88-2564A8031D60}" type="datetimeFigureOut">
              <a:rPr lang="fr-CA" smtClean="0"/>
              <a:pPr/>
              <a:t>2018-01-12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B13B8-C351-4884-A369-C3BB98026AA4}" type="slidenum">
              <a:rPr lang="fr-CA" smtClean="0"/>
              <a:pPr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xmlns="" val="30930648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E00C1F-946C-4921-AD88-2564A8031D60}" type="datetimeFigureOut">
              <a:rPr lang="fr-CA" smtClean="0"/>
              <a:pPr/>
              <a:t>2018-01-12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B13B8-C351-4884-A369-C3BB98026AA4}" type="slidenum">
              <a:rPr lang="fr-CA" smtClean="0"/>
              <a:pPr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xmlns="" val="6294360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E00C1F-946C-4921-AD88-2564A8031D60}" type="datetimeFigureOut">
              <a:rPr lang="fr-CA" smtClean="0"/>
              <a:pPr/>
              <a:t>2018-01-12</a:t>
            </a:fld>
            <a:endParaRPr lang="fr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B13B8-C351-4884-A369-C3BB98026AA4}" type="slidenum">
              <a:rPr lang="fr-CA" smtClean="0"/>
              <a:pPr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xmlns="" val="9148947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E00C1F-946C-4921-AD88-2564A8031D60}" type="datetimeFigureOut">
              <a:rPr lang="fr-CA" smtClean="0"/>
              <a:pPr/>
              <a:t>2018-01-12</a:t>
            </a:fld>
            <a:endParaRPr lang="fr-CA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B13B8-C351-4884-A369-C3BB98026AA4}" type="slidenum">
              <a:rPr lang="fr-CA" smtClean="0"/>
              <a:pPr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xmlns="" val="26379490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E00C1F-946C-4921-AD88-2564A8031D60}" type="datetimeFigureOut">
              <a:rPr lang="fr-CA" smtClean="0"/>
              <a:pPr/>
              <a:t>2018-01-12</a:t>
            </a:fld>
            <a:endParaRPr lang="fr-CA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B13B8-C351-4884-A369-C3BB98026AA4}" type="slidenum">
              <a:rPr lang="fr-CA" smtClean="0"/>
              <a:pPr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xmlns="" val="18730955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E00C1F-946C-4921-AD88-2564A8031D60}" type="datetimeFigureOut">
              <a:rPr lang="fr-CA" smtClean="0"/>
              <a:pPr/>
              <a:t>2018-01-12</a:t>
            </a:fld>
            <a:endParaRPr lang="fr-CA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B13B8-C351-4884-A369-C3BB98026AA4}" type="slidenum">
              <a:rPr lang="fr-CA" smtClean="0"/>
              <a:pPr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xmlns="" val="10200896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E00C1F-946C-4921-AD88-2564A8031D60}" type="datetimeFigureOut">
              <a:rPr lang="fr-CA" smtClean="0"/>
              <a:pPr/>
              <a:t>2018-01-12</a:t>
            </a:fld>
            <a:endParaRPr lang="fr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B13B8-C351-4884-A369-C3BB98026AA4}" type="slidenum">
              <a:rPr lang="fr-CA" smtClean="0"/>
              <a:pPr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xmlns="" val="8916285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CA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E00C1F-946C-4921-AD88-2564A8031D60}" type="datetimeFigureOut">
              <a:rPr lang="fr-CA" smtClean="0"/>
              <a:pPr/>
              <a:t>2018-01-12</a:t>
            </a:fld>
            <a:endParaRPr lang="fr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B13B8-C351-4884-A369-C3BB98026AA4}" type="slidenum">
              <a:rPr lang="fr-CA" smtClean="0"/>
              <a:pPr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xmlns="" val="41396171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E00C1F-946C-4921-AD88-2564A8031D60}" type="datetimeFigureOut">
              <a:rPr lang="fr-CA" smtClean="0"/>
              <a:pPr/>
              <a:t>2018-01-12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8B13B8-C351-4884-A369-C3BB98026AA4}" type="slidenum">
              <a:rPr lang="fr-CA" smtClean="0"/>
              <a:pPr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xmlns="" val="28101947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1" name="Connecteur droit avec flèche 10"/>
          <p:cNvCxnSpPr>
            <a:cxnSpLocks/>
          </p:cNvCxnSpPr>
          <p:nvPr/>
        </p:nvCxnSpPr>
        <p:spPr>
          <a:xfrm rot="-60000" flipH="1">
            <a:off x="9741871" y="3721395"/>
            <a:ext cx="422855" cy="11632"/>
          </a:xfrm>
          <a:prstGeom prst="straightConnector1">
            <a:avLst/>
          </a:prstGeom>
          <a:ln w="57150" cmpd="sng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Connecteur droit avec flèche 18"/>
          <p:cNvCxnSpPr>
            <a:cxnSpLocks/>
          </p:cNvCxnSpPr>
          <p:nvPr/>
        </p:nvCxnSpPr>
        <p:spPr>
          <a:xfrm rot="-1440000" flipH="1">
            <a:off x="5290364" y="2746747"/>
            <a:ext cx="422855" cy="11632"/>
          </a:xfrm>
          <a:prstGeom prst="straightConnector1">
            <a:avLst/>
          </a:prstGeom>
          <a:ln w="57150" cmpd="sng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ZoneTexte 3"/>
          <p:cNvSpPr txBox="1">
            <a:spLocks noChangeArrowheads="1"/>
          </p:cNvSpPr>
          <p:nvPr/>
        </p:nvSpPr>
        <p:spPr bwMode="auto">
          <a:xfrm>
            <a:off x="3537538" y="558631"/>
            <a:ext cx="184731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eaLnBrk="1" fontAlgn="base" hangingPunct="1">
              <a:spcBef>
                <a:spcPct val="0"/>
              </a:spcBef>
              <a:spcAft>
                <a:spcPct val="0"/>
              </a:spcAft>
            </a:pPr>
            <a:endParaRPr lang="fr-CA" altLang="fr-FR" sz="2800" b="1" dirty="0">
              <a:solidFill>
                <a:prstClr val="white"/>
              </a:solidFill>
              <a:cs typeface="Arial" panose="020B0604020202020204" pitchFamily="34" charset="0"/>
            </a:endParaRPr>
          </a:p>
        </p:txBody>
      </p:sp>
      <p:sp>
        <p:nvSpPr>
          <p:cNvPr id="21" name="ZoneTexte 3"/>
          <p:cNvSpPr txBox="1">
            <a:spLocks noChangeArrowheads="1"/>
          </p:cNvSpPr>
          <p:nvPr/>
        </p:nvSpPr>
        <p:spPr bwMode="auto">
          <a:xfrm>
            <a:off x="6770024" y="2331283"/>
            <a:ext cx="444352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eaLnBrk="1" fontAlgn="base" hangingPunct="1">
              <a:spcBef>
                <a:spcPct val="0"/>
              </a:spcBef>
              <a:spcAft>
                <a:spcPct val="0"/>
              </a:spcAft>
            </a:pPr>
            <a:r>
              <a:rPr lang="fr-CA" altLang="fr-FR" sz="2800" b="1" dirty="0">
                <a:cs typeface="Arial" panose="020B0604020202020204" pitchFamily="34" charset="0"/>
              </a:rPr>
              <a:t>B</a:t>
            </a:r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 rotWithShape="1">
          <a:blip r:embed="rId3" cstate="print"/>
          <a:srcRect l="9652" t="7248" r="17734" b="20137"/>
          <a:stretch/>
        </p:blipFill>
        <p:spPr>
          <a:xfrm>
            <a:off x="2243662" y="1472184"/>
            <a:ext cx="2788920" cy="2788920"/>
          </a:xfrm>
          <a:prstGeom prst="rect">
            <a:avLst/>
          </a:prstGeom>
        </p:spPr>
      </p:pic>
      <p:pic>
        <p:nvPicPr>
          <p:cNvPr id="4" name="Image 3"/>
          <p:cNvPicPr>
            <a:picLocks noChangeAspect="1"/>
          </p:cNvPicPr>
          <p:nvPr/>
        </p:nvPicPr>
        <p:blipFill rotWithShape="1">
          <a:blip r:embed="rId4" cstate="print"/>
          <a:srcRect l="10797" t="6978" r="16077" b="26059"/>
          <a:stretch/>
        </p:blipFill>
        <p:spPr>
          <a:xfrm>
            <a:off x="5128883" y="1472184"/>
            <a:ext cx="3045573" cy="2788920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 rotWithShape="1">
          <a:blip r:embed="rId5" cstate="print"/>
          <a:srcRect l="13083" t="5522" r="17510" b="24794"/>
          <a:stretch/>
        </p:blipFill>
        <p:spPr>
          <a:xfrm>
            <a:off x="8311895" y="1472184"/>
            <a:ext cx="2777809" cy="2788920"/>
          </a:xfrm>
          <a:prstGeom prst="rect">
            <a:avLst/>
          </a:prstGeom>
        </p:spPr>
      </p:pic>
      <p:cxnSp>
        <p:nvCxnSpPr>
          <p:cNvPr id="12" name="Connecteur droit avec flèche 11"/>
          <p:cNvCxnSpPr>
            <a:cxnSpLocks/>
          </p:cNvCxnSpPr>
          <p:nvPr/>
        </p:nvCxnSpPr>
        <p:spPr>
          <a:xfrm rot="2160000" flipH="1" flipV="1">
            <a:off x="7250369" y="3647096"/>
            <a:ext cx="406031" cy="89898"/>
          </a:xfrm>
          <a:prstGeom prst="straightConnector1">
            <a:avLst/>
          </a:prstGeom>
          <a:ln w="57150" cmpd="sng">
            <a:solidFill>
              <a:schemeClr val="bg1">
                <a:lumMod val="95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Connecteur droit avec flèche 12"/>
          <p:cNvCxnSpPr>
            <a:cxnSpLocks/>
          </p:cNvCxnSpPr>
          <p:nvPr/>
        </p:nvCxnSpPr>
        <p:spPr>
          <a:xfrm rot="2160000" flipH="1" flipV="1">
            <a:off x="4339529" y="3424592"/>
            <a:ext cx="406031" cy="89898"/>
          </a:xfrm>
          <a:prstGeom prst="straightConnector1">
            <a:avLst/>
          </a:prstGeom>
          <a:ln w="57150" cmpd="sng">
            <a:solidFill>
              <a:schemeClr val="bg1">
                <a:lumMod val="95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Connecteur droit avec flèche 13"/>
          <p:cNvCxnSpPr>
            <a:cxnSpLocks/>
          </p:cNvCxnSpPr>
          <p:nvPr/>
        </p:nvCxnSpPr>
        <p:spPr>
          <a:xfrm rot="-960000" flipH="1" flipV="1">
            <a:off x="10795193" y="2418752"/>
            <a:ext cx="406031" cy="89898"/>
          </a:xfrm>
          <a:prstGeom prst="straightConnector1">
            <a:avLst/>
          </a:prstGeom>
          <a:ln w="57150" cmpd="sng">
            <a:solidFill>
              <a:schemeClr val="bg1">
                <a:lumMod val="95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ZoneTexte 14">
            <a:extLst>
              <a:ext uri="{FF2B5EF4-FFF2-40B4-BE49-F238E27FC236}">
                <a16:creationId xmlns:a16="http://schemas.microsoft.com/office/drawing/2014/main" xmlns="" id="{FAA1E165-4EEC-4490-BBB3-B6110BF864BF}"/>
              </a:ext>
            </a:extLst>
          </p:cNvPr>
          <p:cNvSpPr txBox="1"/>
          <p:nvPr/>
        </p:nvSpPr>
        <p:spPr>
          <a:xfrm>
            <a:off x="461342" y="5732638"/>
            <a:ext cx="113861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b="1" dirty="0" err="1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2</a:t>
            </a:r>
            <a:r>
              <a:rPr lang="en-US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A 62-year-old man presenting with lipomatous metaplasia in the lateral wall of the left ventricle, suggestive of myocardial infarction (arrows).</a:t>
            </a:r>
          </a:p>
        </p:txBody>
      </p:sp>
    </p:spTree>
    <p:extLst>
      <p:ext uri="{BB962C8B-B14F-4D97-AF65-F5344CB8AC3E}">
        <p14:creationId xmlns:p14="http://schemas.microsoft.com/office/powerpoint/2010/main" xmlns="" val="345477274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3</TotalTime>
  <Words>54</Words>
  <Application>Microsoft Office PowerPoint</Application>
  <PresentationFormat>Custom</PresentationFormat>
  <Paragraphs>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hème Offic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arl Chartrand-Lefebvre</dc:creator>
  <cp:lastModifiedBy>0013357</cp:lastModifiedBy>
  <cp:revision>22</cp:revision>
  <dcterms:created xsi:type="dcterms:W3CDTF">2017-03-18T22:22:49Z</dcterms:created>
  <dcterms:modified xsi:type="dcterms:W3CDTF">2018-01-12T14:58:55Z</dcterms:modified>
</cp:coreProperties>
</file>